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E5A5B-22DA-4CC2-B69E-451485326EF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9A9CDB-E104-49B8-BC27-7CE10134E26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EF608-D4AA-4A9B-9082-9B53670B87D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EB5BD6-2DF5-4E0D-9746-A4B7EBE484F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76B394-2359-4DA9-9C3E-68E3916BF4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E7F2DF-73A4-4B47-83F4-F1EB5D9C1E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37BBFF-F759-42F3-BF3E-64BDDB373F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D1C4E1-71DE-4FE2-8134-0719255B60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A1B37B-5E59-4CC8-B90F-25A5D32D61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0D9052-15A4-4EDA-8544-9A5975A7F4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F48CBA-7AF4-4EDE-A8BF-0B42A22D9F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B0969-228A-46DD-89EF-64CDA40255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9DC9E4-3B5A-4FC2-906E-FCEB7960832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990720" y="6265080"/>
            <a:ext cx="678168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Calibri"/>
              </a:rPr>
              <a:t>Figure S8.  GO annotation of 358 candidate pathogenicity proteins based on biological process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Chart 3" descr=""/>
          <p:cNvPicPr/>
          <p:nvPr/>
        </p:nvPicPr>
        <p:blipFill>
          <a:blip r:embed="rId1"/>
          <a:stretch/>
        </p:blipFill>
        <p:spPr>
          <a:xfrm>
            <a:off x="835200" y="457200"/>
            <a:ext cx="8083440" cy="5791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>Sahu, Binod B [AGRON]</dc:creator>
  <dc:description/>
  <dc:language>en-US</dc:language>
  <cp:lastModifiedBy>Bhattacharyya, Madan K [AGRON]</cp:lastModifiedBy>
  <dcterms:modified xsi:type="dcterms:W3CDTF">2013-06-09T00:46:56Z</dcterms:modified>
  <cp:revision>21</cp:revision>
  <dc:subject/>
  <dc:title>Slide 1</dc:title>
</cp:coreProperties>
</file>